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6858000"/>
  <p:notesSz cx="6804025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E21833-8D7C-49B2-8AC2-4E6E8D81908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274320"/>
            <a:ext cx="6172200" cy="114300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1600200"/>
            <a:ext cx="6172200" cy="21585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3964320"/>
            <a:ext cx="6172200" cy="21585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B1C9A8-4791-4190-BDF8-C03DB9731B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274320"/>
            <a:ext cx="6172200" cy="114300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1600200"/>
            <a:ext cx="3011760" cy="21585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1600200"/>
            <a:ext cx="3011760" cy="21585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3964320"/>
            <a:ext cx="3011760" cy="21585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3964320"/>
            <a:ext cx="3011760" cy="21585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C58946-A239-4926-8354-CD1BEC2B471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274320"/>
            <a:ext cx="6172200" cy="114300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1600200"/>
            <a:ext cx="1987200" cy="21585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1600200"/>
            <a:ext cx="1987200" cy="21585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1600200"/>
            <a:ext cx="1987200" cy="21585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3964320"/>
            <a:ext cx="1987200" cy="21585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3964320"/>
            <a:ext cx="1987200" cy="21585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3964320"/>
            <a:ext cx="1987200" cy="21585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7053AE-C4A8-4CEF-AEC9-DAD430CD775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274320"/>
            <a:ext cx="6172200" cy="114300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1600200"/>
            <a:ext cx="61722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0F6CDB-8C78-4B98-82DA-CD582D5107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274320"/>
            <a:ext cx="6172200" cy="114300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1600200"/>
            <a:ext cx="6172200" cy="452592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EA9621-1430-4775-9C20-30AE78C16A5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274320"/>
            <a:ext cx="6172200" cy="114300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1600200"/>
            <a:ext cx="3011760" cy="452592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1600200"/>
            <a:ext cx="3011760" cy="452592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133662-EA13-481A-9C85-B703BC6A26E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274320"/>
            <a:ext cx="6172200" cy="114300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5D70C7-6EA3-4513-920C-A650A20504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274320"/>
            <a:ext cx="61722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00"/>
              </a:spcBef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C720EF-D371-4664-8E15-BCA31ACCDA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274320"/>
            <a:ext cx="6172200" cy="114300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1600200"/>
            <a:ext cx="3011760" cy="21585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1600200"/>
            <a:ext cx="3011760" cy="452592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3964320"/>
            <a:ext cx="3011760" cy="21585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F53F87-4665-4F9A-954C-E7181BFDDD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274320"/>
            <a:ext cx="6172200" cy="114300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1600200"/>
            <a:ext cx="3011760" cy="452592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1600200"/>
            <a:ext cx="3011760" cy="21585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3964320"/>
            <a:ext cx="3011760" cy="21585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E90F9F-C180-4396-AA5A-182AC9CB02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274320"/>
            <a:ext cx="6172200" cy="114300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1600200"/>
            <a:ext cx="3011760" cy="21585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1600200"/>
            <a:ext cx="3011760" cy="21585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3964320"/>
            <a:ext cx="6172200" cy="21585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1DC3E9-574B-4CA9-88B1-F24D0A8F6B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274320"/>
            <a:ext cx="6172200" cy="114300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1600200"/>
            <a:ext cx="6172200" cy="452592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marL="298440" indent="-29844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47640" indent="-24912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996840" indent="-19980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395360" indent="-19836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1793880" indent="-19836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1793880" indent="-19836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1793880" indent="-19836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6356520"/>
            <a:ext cx="1600200" cy="36504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lstStyle>
            <a:lvl1pPr indent="0">
              <a:buNone/>
              <a:tabLst>
                <a:tab algn="l" pos="0"/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  <a:defRPr b="0" lang="ja-JP" sz="10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r>
              <a:rPr b="0" lang="ja-JP" sz="10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6356520"/>
            <a:ext cx="2171520" cy="36504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6356520"/>
            <a:ext cx="1600200" cy="36504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lstStyle>
            <a:lvl1pPr indent="0" algn="r">
              <a:buNone/>
              <a:tabLst>
                <a:tab algn="l" pos="0"/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  <a:defRPr b="0" lang="ja-JP" sz="10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fld id="{048CE778-69CF-4B54-8A9D-F323E9BFE2C4}" type="slidenum">
              <a:rPr b="0" lang="ja-JP" sz="10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タイトル 6"/>
          <p:cNvSpPr/>
          <p:nvPr/>
        </p:nvSpPr>
        <p:spPr>
          <a:xfrm>
            <a:off x="1531800" y="446040"/>
            <a:ext cx="4332600" cy="405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2040" rIns="122040" tIns="61200" bIns="61200" anchor="ctr">
            <a:noAutofit/>
          </a:bodyPr>
          <a:p>
            <a:pPr marL="343080" indent="-343080"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ure S2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243000" y="1109520"/>
            <a:ext cx="6400800" cy="5456880"/>
            <a:chOff x="243000" y="1109520"/>
            <a:chExt cx="6400800" cy="5456880"/>
          </a:xfrm>
        </p:grpSpPr>
        <p:pic>
          <p:nvPicPr>
            <p:cNvPr id="43" name="Picture 2" descr=""/>
            <p:cNvPicPr/>
            <p:nvPr/>
          </p:nvPicPr>
          <p:blipFill>
            <a:blip r:embed="rId1"/>
            <a:stretch/>
          </p:blipFill>
          <p:spPr>
            <a:xfrm>
              <a:off x="1949400" y="2189160"/>
              <a:ext cx="3689640" cy="919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3" descr=""/>
            <p:cNvPicPr/>
            <p:nvPr/>
          </p:nvPicPr>
          <p:blipFill>
            <a:blip r:embed="rId2"/>
            <a:stretch/>
          </p:blipFill>
          <p:spPr>
            <a:xfrm>
              <a:off x="1949400" y="3136680"/>
              <a:ext cx="3689640" cy="930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8" descr=""/>
            <p:cNvPicPr/>
            <p:nvPr/>
          </p:nvPicPr>
          <p:blipFill>
            <a:blip r:embed="rId3"/>
            <a:stretch/>
          </p:blipFill>
          <p:spPr>
            <a:xfrm>
              <a:off x="1949400" y="4101840"/>
              <a:ext cx="3697560" cy="911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Text Box 9"/>
            <p:cNvSpPr/>
            <p:nvPr/>
          </p:nvSpPr>
          <p:spPr>
            <a:xfrm>
              <a:off x="622800" y="2438280"/>
              <a:ext cx="99144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olactin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Text Box 10"/>
            <p:cNvSpPr/>
            <p:nvPr/>
          </p:nvSpPr>
          <p:spPr>
            <a:xfrm>
              <a:off x="624600" y="3446280"/>
              <a:ext cx="98964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IGFBP-1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Text Box 25"/>
            <p:cNvSpPr/>
            <p:nvPr/>
          </p:nvSpPr>
          <p:spPr>
            <a:xfrm>
              <a:off x="790560" y="4341600"/>
              <a:ext cx="77004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l-GR" sz="2000" spc="-1" strike="noStrike">
                  <a:solidFill>
                    <a:srgbClr val="000000"/>
                  </a:solidFill>
                  <a:latin typeface="Arial"/>
                  <a:ea typeface="Arial Unicode MS"/>
                </a:rPr>
                <a:t>β-</a:t>
              </a: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 Unicode MS"/>
                </a:rPr>
                <a:t>actin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Rectangle 55"/>
            <p:cNvSpPr/>
            <p:nvPr/>
          </p:nvSpPr>
          <p:spPr>
            <a:xfrm>
              <a:off x="2193120" y="1109520"/>
              <a:ext cx="8604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Rectangle 56"/>
            <p:cNvSpPr/>
            <p:nvPr/>
          </p:nvSpPr>
          <p:spPr>
            <a:xfrm>
              <a:off x="3353760" y="1109520"/>
              <a:ext cx="8604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Rectangle 57"/>
            <p:cNvSpPr/>
            <p:nvPr/>
          </p:nvSpPr>
          <p:spPr>
            <a:xfrm>
              <a:off x="2751840" y="1109520"/>
              <a:ext cx="1501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Rectangle 58"/>
            <p:cNvSpPr/>
            <p:nvPr/>
          </p:nvSpPr>
          <p:spPr>
            <a:xfrm>
              <a:off x="3940920" y="1109520"/>
              <a:ext cx="1501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Rectangle 57"/>
            <p:cNvSpPr/>
            <p:nvPr/>
          </p:nvSpPr>
          <p:spPr>
            <a:xfrm>
              <a:off x="4553640" y="1109520"/>
              <a:ext cx="1501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Rectangle 58"/>
            <p:cNvSpPr/>
            <p:nvPr/>
          </p:nvSpPr>
          <p:spPr>
            <a:xfrm>
              <a:off x="5175720" y="1109520"/>
              <a:ext cx="1501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Rectangle 55"/>
            <p:cNvSpPr/>
            <p:nvPr/>
          </p:nvSpPr>
          <p:spPr>
            <a:xfrm>
              <a:off x="2193120" y="1430280"/>
              <a:ext cx="8604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Rectangle 56"/>
            <p:cNvSpPr/>
            <p:nvPr/>
          </p:nvSpPr>
          <p:spPr>
            <a:xfrm>
              <a:off x="3321720" y="1430280"/>
              <a:ext cx="1501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Rectangle 57"/>
            <p:cNvSpPr/>
            <p:nvPr/>
          </p:nvSpPr>
          <p:spPr>
            <a:xfrm>
              <a:off x="2783880" y="1430280"/>
              <a:ext cx="8604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Rectangle 58"/>
            <p:cNvSpPr/>
            <p:nvPr/>
          </p:nvSpPr>
          <p:spPr>
            <a:xfrm>
              <a:off x="3940920" y="1430280"/>
              <a:ext cx="1501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Rectangle 57"/>
            <p:cNvSpPr/>
            <p:nvPr/>
          </p:nvSpPr>
          <p:spPr>
            <a:xfrm>
              <a:off x="4553640" y="1430280"/>
              <a:ext cx="1501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Rectangle 58"/>
            <p:cNvSpPr/>
            <p:nvPr/>
          </p:nvSpPr>
          <p:spPr>
            <a:xfrm>
              <a:off x="5207760" y="1430280"/>
              <a:ext cx="8604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Rectangle 55"/>
            <p:cNvSpPr/>
            <p:nvPr/>
          </p:nvSpPr>
          <p:spPr>
            <a:xfrm>
              <a:off x="2193120" y="1752480"/>
              <a:ext cx="8604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Rectangle 56"/>
            <p:cNvSpPr/>
            <p:nvPr/>
          </p:nvSpPr>
          <p:spPr>
            <a:xfrm>
              <a:off x="3353760" y="1752480"/>
              <a:ext cx="8604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Rectangle 57"/>
            <p:cNvSpPr/>
            <p:nvPr/>
          </p:nvSpPr>
          <p:spPr>
            <a:xfrm>
              <a:off x="2783880" y="1752480"/>
              <a:ext cx="8604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Rectangle 58"/>
            <p:cNvSpPr/>
            <p:nvPr/>
          </p:nvSpPr>
          <p:spPr>
            <a:xfrm>
              <a:off x="3972960" y="1752480"/>
              <a:ext cx="8604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Rectangle 57"/>
            <p:cNvSpPr/>
            <p:nvPr/>
          </p:nvSpPr>
          <p:spPr>
            <a:xfrm>
              <a:off x="4553640" y="1752480"/>
              <a:ext cx="1501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Rectangle 58"/>
            <p:cNvSpPr/>
            <p:nvPr/>
          </p:nvSpPr>
          <p:spPr>
            <a:xfrm>
              <a:off x="5175720" y="1752480"/>
              <a:ext cx="1501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Rectangle 55"/>
            <p:cNvSpPr/>
            <p:nvPr/>
          </p:nvSpPr>
          <p:spPr>
            <a:xfrm>
              <a:off x="928440" y="1109520"/>
              <a:ext cx="31176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E2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Rectangle 55"/>
            <p:cNvSpPr/>
            <p:nvPr/>
          </p:nvSpPr>
          <p:spPr>
            <a:xfrm>
              <a:off x="928800" y="1430280"/>
              <a:ext cx="55080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PA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Rectangle 55"/>
            <p:cNvSpPr/>
            <p:nvPr/>
          </p:nvSpPr>
          <p:spPr>
            <a:xfrm>
              <a:off x="928440" y="1752480"/>
              <a:ext cx="67896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AMP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正方形/長方形 96"/>
            <p:cNvSpPr/>
            <p:nvPr/>
          </p:nvSpPr>
          <p:spPr>
            <a:xfrm>
              <a:off x="243000" y="5406840"/>
              <a:ext cx="6400800" cy="11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Long-term maintenance of KC02-44D cells.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KC02-44D cells at passage number 37 (10-month cultured) tested for their ability to decidualize in response to 6 days of stimulation with ovarian steroids and cAMP. Transcript levels of prolactin and IGFBP-1 were determined by RT-PCR; </a:t>
              </a:r>
              <a:r>
                <a:rPr b="0" lang="el-GR" sz="1400" spc="-1" strike="noStrike">
                  <a:solidFill>
                    <a:srgbClr val="000000"/>
                  </a:solidFill>
                  <a:latin typeface="Arial"/>
                  <a:ea typeface="Arial Unicode MS"/>
                </a:rPr>
                <a:t>β-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actin mRNA was amplified for normalization. 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96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1999-12-04T05:57:58Z</dcterms:created>
  <dc:creator>NRRC Client</dc:creator>
  <dc:description/>
  <dc:language>en-US</dc:language>
  <cp:lastModifiedBy>Antonin</cp:lastModifiedBy>
  <cp:lastPrinted>2000-04-18T05:06:02Z</cp:lastPrinted>
  <dcterms:modified xsi:type="dcterms:W3CDTF">2011-07-22T20:12:09Z</dcterms:modified>
  <cp:revision>1342</cp:revision>
  <dc:subject/>
  <dc:title>ｽﾗｲﾄﾞ ﾀｲﾄﾙなし</dc:title>
</cp:coreProperties>
</file>